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190C7-D70C-43B7-B7EE-CF5DC4B8B7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6B1FE-6B39-4070-B053-2CB1AD27A2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696D9-B2C9-4328-BD6A-CD2F5B7359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BAC677-CA0A-4828-B0EF-CB92F9CC0B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D02527-90AE-49EB-90C4-181E9C62AF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092C4-6D8B-4DB6-94D6-E2D0AC03B1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5DF939-3C36-468D-AA28-601E809EE2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6E3756-A3D3-4B92-A436-8E03F5D71D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551D1-9571-4AFD-BEE6-340CD349D2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8766C-76F9-4962-8B40-85818F2F53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FD0EE-6631-4F5C-A2CB-55DD33276E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9026D3-8D74-4A14-8D49-B2C0BAD424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D792AE-F60C-4DDD-9982-93655AFAF40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265040" y="3650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647720" y="236520"/>
            <a:ext cx="5840640" cy="6486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"/>
          <p:cNvGrpSpPr/>
          <p:nvPr/>
        </p:nvGrpSpPr>
        <p:grpSpPr>
          <a:xfrm>
            <a:off x="480960" y="982800"/>
            <a:ext cx="3499920" cy="4257000"/>
            <a:chOff x="480960" y="982800"/>
            <a:chExt cx="3499920" cy="4257000"/>
          </a:xfrm>
        </p:grpSpPr>
        <p:pic>
          <p:nvPicPr>
            <p:cNvPr id="44" name="" descr=""/>
            <p:cNvPicPr/>
            <p:nvPr/>
          </p:nvPicPr>
          <p:blipFill>
            <a:blip r:embed="rId1"/>
            <a:srcRect l="2540" t="14305" r="17989" b="4768"/>
            <a:stretch/>
          </p:blipFill>
          <p:spPr>
            <a:xfrm>
              <a:off x="681120" y="1404720"/>
              <a:ext cx="2595600" cy="1625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2"/>
            <a:srcRect l="3325" t="12078" r="17989" b="5407"/>
            <a:stretch/>
          </p:blipFill>
          <p:spPr>
            <a:xfrm>
              <a:off x="714240" y="3254040"/>
              <a:ext cx="2587680" cy="166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1398960" y="4854240"/>
              <a:ext cx="1463760" cy="385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ubercidin (µg/m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repress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ng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392840" y="2962080"/>
              <a:ext cx="1463760" cy="385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ubercidin (µg/m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non-repress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ng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6200000">
              <a:off x="260280" y="1902240"/>
              <a:ext cx="86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% growt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6200000">
              <a:off x="254160" y="3750120"/>
              <a:ext cx="86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% growt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80960" y="98280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"/>
            <p:cNvGrpSpPr/>
            <p:nvPr/>
          </p:nvGrpSpPr>
          <p:grpSpPr>
            <a:xfrm>
              <a:off x="3325680" y="1606320"/>
              <a:ext cx="642600" cy="855360"/>
              <a:chOff x="3325680" y="1606320"/>
              <a:chExt cx="642600" cy="855360"/>
            </a:xfrm>
          </p:grpSpPr>
          <p:sp>
            <p:nvSpPr>
              <p:cNvPr id="52" name=""/>
              <p:cNvSpPr/>
              <p:nvPr/>
            </p:nvSpPr>
            <p:spPr>
              <a:xfrm>
                <a:off x="3394440" y="1606320"/>
                <a:ext cx="573840" cy="855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HIS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FCY2*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FCY2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NNT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DIP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398760" y="1680840"/>
                <a:ext cx="88920" cy="88920"/>
              </a:xfrm>
              <a:prstGeom prst="ellipse">
                <a:avLst/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6200" bIns="16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3389040" y="1828440"/>
                <a:ext cx="103320" cy="8892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7280" bIns="-17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3398760" y="2138040"/>
                <a:ext cx="88920" cy="889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2120" bIns="421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3394080" y="2295360"/>
                <a:ext cx="88920" cy="88920"/>
              </a:xfrm>
              <a:prstGeom prst="diamond">
                <a:avLst/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" bIns="-21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3325680" y="1936440"/>
                <a:ext cx="249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X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" name=""/>
            <p:cNvGrpSpPr/>
            <p:nvPr/>
          </p:nvGrpSpPr>
          <p:grpSpPr>
            <a:xfrm>
              <a:off x="3402000" y="3479760"/>
              <a:ext cx="578880" cy="855360"/>
              <a:chOff x="3402000" y="3479760"/>
              <a:chExt cx="578880" cy="855360"/>
            </a:xfrm>
          </p:grpSpPr>
          <p:sp>
            <p:nvSpPr>
              <p:cNvPr id="59" name=""/>
              <p:cNvSpPr/>
              <p:nvPr/>
            </p:nvSpPr>
            <p:spPr>
              <a:xfrm>
                <a:off x="3407040" y="3479760"/>
                <a:ext cx="573840" cy="855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HIS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FCY2*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FCY2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NNT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</a:rPr>
                  <a:t>DIP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411720" y="3553920"/>
                <a:ext cx="88920" cy="88560"/>
              </a:xfrm>
              <a:prstGeom prst="ellipse">
                <a:avLst/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840" bIns="15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402000" y="3701520"/>
                <a:ext cx="103320" cy="8856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7280" bIns="-17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3411720" y="4020480"/>
                <a:ext cx="88920" cy="885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1760" bIns="41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407040" y="4177800"/>
                <a:ext cx="88920" cy="88560"/>
              </a:xfrm>
              <a:prstGeom prst="diamond">
                <a:avLst/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60" bIns="-21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3402000" y="3853800"/>
                <a:ext cx="103320" cy="88560"/>
              </a:xfrm>
              <a:prstGeom prst="triangle">
                <a:avLst>
                  <a:gd name="adj" fmla="val 50000"/>
                </a:avLst>
              </a:prstGeom>
              <a:solidFill>
                <a:srgbClr val="80808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7280" bIns="-17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5" name=""/>
          <p:cNvSpPr/>
          <p:nvPr/>
        </p:nvSpPr>
        <p:spPr>
          <a:xfrm>
            <a:off x="4265640" y="741240"/>
            <a:ext cx="4354560" cy="520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5-FU, 5-FC, tubercidin and 6-AU, and characterization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. albican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nucleoside transporter Nnt1p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ing of 5-FU, 5-FC, tubercidin and 6-AU. The selection of strains was based on their responses to 5-FU, 5-FC and tubercidin (see text for detail) with orf19 designations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S. cerevisia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orthologous genes indicated. The z-scores are shown with those greater than 3.000 highlighted in red, and lower than -3.000 in blue (black filling indicating ND = not determined). Black boxes indicate strains representing genes involved in pre-rRNA processing and ribosomal biogenesis. The experimental conditions are: 5-FC: 1, 0.006 µg/ml (F=0.89); 2, 0.010 µg/ml (F=0.61); 3, 0.014 µg/ml (F=0.57), 5-FU: 4, 2.5 µg/ml (F=0.94); 5, 4.5 µg/ml (F=0.75); 6, 3.5 µg/ml (F=0.82); tubercidin: 7, 0.80 µg/ml (F=0.89); 8, 0.95 µg/ml (F=0.80); 9, 1.15 µg/ml (F=0.69); and 6-AU: 10, 0.70 µg/ml (F=0.88); 11, 0.90 µg/ml (F=0.77); 12, 1.05 µg/ml (F=0.72). The green box highlights three resistant strains, the corresponding genes of which are involved in the uptake or metabolism of 5-FC/5-FU or tubercidin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haracterization of selected conditional shut-off strains under the non-repressing (top) and the repressing (bottom) conditions against tubercidin. Note that only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NNT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strain displays dimorphic responses to tubercidin; i.e., increased susceptibility under the non-repressing conditions (likely due to overexpression of the transporter; i.e., enhanced uptake of the compound) and resistance under the repressing conditions (i.e., reduced uptake when the transporter is depleted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14:47:32Z</dcterms:created>
  <dc:creator>xudemin</dc:creator>
  <dc:description/>
  <dc:language>en-US</dc:language>
  <cp:lastModifiedBy>xudemin</cp:lastModifiedBy>
  <dcterms:modified xsi:type="dcterms:W3CDTF">2007-05-17T15:25:16Z</dcterms:modified>
  <cp:revision>4</cp:revision>
  <dc:subject/>
  <dc:title>Slide 1</dc:title>
</cp:coreProperties>
</file>